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30" d="100"/>
          <a:sy n="130" d="100"/>
        </p:scale>
        <p:origin x="96" y="-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331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759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3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8326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013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88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1197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242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78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2733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963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E1605-6367-4323-82E4-A92F89ADC00B}" type="datetimeFigureOut">
              <a:rPr lang="en-GB" smtClean="0"/>
              <a:t>29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9B398-7DF5-43F8-AAE3-85DA806A943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988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1679013"/>
              </p:ext>
            </p:extLst>
          </p:nvPr>
        </p:nvGraphicFramePr>
        <p:xfrm>
          <a:off x="1974018" y="25165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SPW 12.0 Graph" r:id="rId3" imgW="5276843" imgH="4029134" progId="SigmaPlotGraphicObject.11">
                  <p:embed/>
                </p:oleObj>
              </mc:Choice>
              <mc:Fallback>
                <p:oleObj name="SPW 12.0 Graph" r:id="rId3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74018" y="25165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1417566"/>
              </p:ext>
            </p:extLst>
          </p:nvPr>
        </p:nvGraphicFramePr>
        <p:xfrm>
          <a:off x="4612440" y="25165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SPW 12.0 Graph" r:id="rId5" imgW="5276843" imgH="4029134" progId="SigmaPlotGraphicObject.11">
                  <p:embed/>
                </p:oleObj>
              </mc:Choice>
              <mc:Fallback>
                <p:oleObj name="SPW 12.0 Graph" r:id="rId5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12440" y="25165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601867"/>
              </p:ext>
            </p:extLst>
          </p:nvPr>
        </p:nvGraphicFramePr>
        <p:xfrm>
          <a:off x="1974018" y="4202754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SPW 12.0 Graph" r:id="rId7" imgW="5276843" imgH="4029134" progId="SigmaPlotGraphicObject.11">
                  <p:embed/>
                </p:oleObj>
              </mc:Choice>
              <mc:Fallback>
                <p:oleObj name="SPW 12.0 Graph" r:id="rId7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74018" y="4202754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0736507"/>
              </p:ext>
            </p:extLst>
          </p:nvPr>
        </p:nvGraphicFramePr>
        <p:xfrm>
          <a:off x="7250862" y="251651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SPW 12.0 Graph" r:id="rId9" imgW="5276843" imgH="4029134" progId="SigmaPlotGraphicObject.11">
                  <p:embed/>
                </p:oleObj>
              </mc:Choice>
              <mc:Fallback>
                <p:oleObj name="SPW 12.0 Graph" r:id="rId9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250862" y="251651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2559518"/>
              </p:ext>
            </p:extLst>
          </p:nvPr>
        </p:nvGraphicFramePr>
        <p:xfrm>
          <a:off x="1974018" y="2188187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SPW 12.0 Graph" r:id="rId11" imgW="5276843" imgH="4029134" progId="SigmaPlotGraphicObject.11">
                  <p:embed/>
                </p:oleObj>
              </mc:Choice>
              <mc:Fallback>
                <p:oleObj name="SPW 12.0 Graph" r:id="rId11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74018" y="2188187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743431"/>
              </p:ext>
            </p:extLst>
          </p:nvPr>
        </p:nvGraphicFramePr>
        <p:xfrm>
          <a:off x="7250862" y="2188187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SPW 12.0 Graph" r:id="rId13" imgW="5276843" imgH="4029134" progId="SigmaPlotGraphicObject.11">
                  <p:embed/>
                </p:oleObj>
              </mc:Choice>
              <mc:Fallback>
                <p:oleObj name="SPW 12.0 Graph" r:id="rId13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250862" y="2188187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7694470"/>
              </p:ext>
            </p:extLst>
          </p:nvPr>
        </p:nvGraphicFramePr>
        <p:xfrm>
          <a:off x="4612440" y="2188187"/>
          <a:ext cx="2638422" cy="2014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SPW 12.0 Graph" r:id="rId15" imgW="5276843" imgH="4029134" progId="SigmaPlotGraphicObject.11">
                  <p:embed/>
                </p:oleObj>
              </mc:Choice>
              <mc:Fallback>
                <p:oleObj name="SPW 12.0 Graph" r:id="rId15" imgW="5276843" imgH="4029134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612440" y="2188187"/>
                        <a:ext cx="2638422" cy="2014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155063" y="66985"/>
            <a:ext cx="1592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. 3: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974018" y="6217321"/>
            <a:ext cx="77599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. 3: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N-PAG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gra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fil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uni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ts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tsHi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MDH complex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ildtype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lso Fig. 4 C). The BN-PAG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lic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x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not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mo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vid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y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398256" y="4347256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N-PAGE Gel slice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6200000">
            <a:off x="1110962" y="3539753"/>
            <a:ext cx="1479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r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undanc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mo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0319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SigmaPlot 12.0 Graph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cha</dc:creator>
  <cp:lastModifiedBy>Sacha</cp:lastModifiedBy>
  <cp:revision>2</cp:revision>
  <dcterms:created xsi:type="dcterms:W3CDTF">2019-01-29T08:22:31Z</dcterms:created>
  <dcterms:modified xsi:type="dcterms:W3CDTF">2019-01-29T08:28:58Z</dcterms:modified>
</cp:coreProperties>
</file>